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5400675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94673"/>
  </p:normalViewPr>
  <p:slideViewPr>
    <p:cSldViewPr snapToGrid="0" snapToObjects="1" showGuides="1">
      <p:cViewPr varScale="1">
        <p:scale>
          <a:sx n="172" d="100"/>
          <a:sy n="172" d="100"/>
        </p:scale>
        <p:origin x="2120" y="192"/>
      </p:cViewPr>
      <p:guideLst>
        <p:guide orient="horz" pos="2160"/>
        <p:guide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1122363"/>
            <a:ext cx="4590574" cy="2387600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3602038"/>
            <a:ext cx="4050506" cy="1655762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121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80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365125"/>
            <a:ext cx="116452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365125"/>
            <a:ext cx="3426053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326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825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709740"/>
            <a:ext cx="4658082" cy="2852737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4589465"/>
            <a:ext cx="4658082" cy="1500187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391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825625"/>
            <a:ext cx="2295287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825625"/>
            <a:ext cx="2295287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778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65127"/>
            <a:ext cx="4658082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681163"/>
            <a:ext cx="2284738" cy="823912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2505075"/>
            <a:ext cx="228473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681163"/>
            <a:ext cx="2295990" cy="823912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2505075"/>
            <a:ext cx="229599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865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594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629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457200"/>
            <a:ext cx="1741858" cy="1600200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987427"/>
            <a:ext cx="2734092" cy="4873625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057400"/>
            <a:ext cx="1741858" cy="3811588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11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457200"/>
            <a:ext cx="1741858" cy="1600200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987427"/>
            <a:ext cx="2734092" cy="4873625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057400"/>
            <a:ext cx="1741858" cy="3811588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275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365127"/>
            <a:ext cx="465808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825625"/>
            <a:ext cx="465808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6356352"/>
            <a:ext cx="12151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524F2-45AB-7140-AC0A-218419182A95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6356352"/>
            <a:ext cx="182272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6356352"/>
            <a:ext cx="12151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72E10-632F-A240-9F54-0B7BDEB1E5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938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kumimoji="1"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3FB9322-4DDC-1A40-90A6-B77E029AE0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084" y="1329924"/>
            <a:ext cx="3825913" cy="3188261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7E1604FD-1108-924F-A9A4-212074FA7902}"/>
              </a:ext>
            </a:extLst>
          </p:cNvPr>
          <p:cNvSpPr/>
          <p:nvPr/>
        </p:nvSpPr>
        <p:spPr>
          <a:xfrm>
            <a:off x="760308" y="441661"/>
            <a:ext cx="215956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ja-JP" altLang="ja-JP" sz="11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kumimoji="0"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extraction flow. </a:t>
            </a:r>
            <a:endParaRPr lang="ja-JP" altLang="en-US" sz="11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D9AE6F-4708-C041-82FA-01A2F16BC586}"/>
              </a:ext>
            </a:extLst>
          </p:cNvPr>
          <p:cNvSpPr txBox="1"/>
          <p:nvPr/>
        </p:nvSpPr>
        <p:spPr>
          <a:xfrm>
            <a:off x="760308" y="4861932"/>
            <a:ext cx="43023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ong 23,284 examined genes, 1526 were significantly altered (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.1; &gt;2-fold change): 547 upregulated and 979 downregulated</a:t>
            </a:r>
            <a:r>
              <a:rPr lang="en-US" altLang="ja-JP" sz="1000" dirty="0"/>
              <a:t>.</a:t>
            </a:r>
            <a:endParaRPr kumimoji="1"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1528153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32</Words>
  <Application>Microsoft Macintosh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柴山 幸子</dc:creator>
  <cp:lastModifiedBy>柴山 幸子</cp:lastModifiedBy>
  <cp:revision>4</cp:revision>
  <dcterms:created xsi:type="dcterms:W3CDTF">2019-12-23T13:05:25Z</dcterms:created>
  <dcterms:modified xsi:type="dcterms:W3CDTF">2019-12-23T13:44:45Z</dcterms:modified>
</cp:coreProperties>
</file>